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2808"/>
  </p:normalViewPr>
  <p:slideViewPr>
    <p:cSldViewPr snapToGrid="0" showGuides="1">
      <p:cViewPr varScale="1">
        <p:scale>
          <a:sx n="85" d="100"/>
          <a:sy n="85" d="100"/>
        </p:scale>
        <p:origin x="1496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E14C78-2FD8-C847-8946-97D9AD8AC460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C74C1-06EC-9D42-BC59-97A9EEDC8A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93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6C74C1-06EC-9D42-BC59-97A9EEDC8A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413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42A8F-FCA9-6ADC-0317-526F600743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2016873-4E45-86FA-DF47-2A96F578C4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23FDEC-3455-88B5-7989-25B9A5491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8752E-C7E2-C4F8-0D14-F46B52A00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A984B-E180-7AD2-E158-74C89E591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466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DA57B-60B8-9F5F-B36E-EB70846A6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46E9F0-6865-E62E-74FA-90C603DF0A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D230D-9CAC-8CB9-CFAD-56A2B7123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DD932C-BAA6-070F-F429-AD35587B2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AD972-C874-B1F9-4683-46BB5BC6E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95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59ADC4-CAD6-AED1-A840-E66F14BE4E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DC8CDA-362C-07BD-B2CF-FAAB4EFF26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5A567-8ED6-17C3-30A0-E89066846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55168-D654-39A9-FC5D-66F64CAF9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275727-0CE6-43E3-C852-2C5F9FD08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761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9A324-7C8B-4A90-AE12-671FF35A70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DDCB6D-A9EF-0013-D57D-EBD1A1CB3F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ECFEF7-888E-BABF-D9D8-624B5C9DC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BCCE1-19E2-0A3A-1855-46EEB614B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CB1920-A280-06EE-39FD-6B3B37B29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105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85FCD-8F0E-4B89-9A8F-437D8E1D9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283283-D4FF-7DF8-DFD2-C54B4D46A8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F6B455-0D4C-AC49-9EF1-DB61F941E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738EF5-C6D8-2809-423A-C29503572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4CBB96-57FB-66E7-95ED-D262D618E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212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541F72-2F85-D7B0-6B5F-EB91C59F6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F04075-108B-A9D6-030C-84AE3E1D43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0BA1F5-5EB7-A7C0-E099-FAFBD23EF7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020877-F315-943B-1E30-D51CFAB77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5EB9F5-102B-5A94-DC58-355D91CC0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01B258-A0FF-C883-10C4-02EA7A73E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901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94B6F5-B4F2-B822-6591-0E240E81C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FCA9C1-9AA4-5037-B715-F1D6B627F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C60174-5B8A-C22A-4737-CE6FCF376E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CB6EC2-33A2-80E0-D27F-D4186E56AC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E1AD48-9585-1122-FB06-725810B732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B339A0-A084-9DEC-EE6D-DFE39EF77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936531F-451B-B407-6670-9A7C30625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0FD308-60B8-526D-964A-CC472C254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94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B8C100-EAD5-0382-497E-B42A70B2D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6D9111-EFA3-2CAB-64F5-C5F62FA09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0C7DC0-5648-F54E-887B-4D74AAD74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4F3686-D9BA-9649-DC59-544B8E83E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789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19F5A8-351C-3363-8144-724A42DE5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D97601-F4EE-73B9-5271-6F59BC1C3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605523-B276-2EEF-CF26-C08827971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184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CA5FE-398F-E5F8-C75B-14F5F5E60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A52222-66B6-979E-A282-FA5201AC31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48DE68-9BBC-1A65-37D6-E1F383E75A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762511-F990-51B9-05C7-8C360D4BE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99A2B1-FB99-2050-0535-77A3CBC48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B3F833-F7D8-7CBC-F3BB-57E31696B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360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6E2CB-FDF9-CD92-7548-D58D825C8C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B58196-E7F0-F01A-9618-BE68E0A0CB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5945FB-BA00-E43B-667E-7147D525F4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1C3C8-4223-66DD-A134-D1A3F78C4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6C0088-75D9-2761-D0C3-51A3F3144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E7934E-2FFF-02C3-A277-2C9ACE544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329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8AFF67-B1F4-1CF8-53C1-FD35B6D7A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07CB49-9396-3E05-5D08-DBF90E2314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A77CF7-2E7F-E2DD-49AC-542583E109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2DBF0C-67D8-294B-8D32-2460D3A3AF5C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F4CDA-7FC3-EAE3-601F-CD2A0692D4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8DAA1-1526-1D6D-681E-DFFAD0879E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24DF27-79F2-B046-B64E-4B371C52C6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575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39AC919B-5CC6-08CA-EDBC-3AC960D8D519}"/>
              </a:ext>
            </a:extLst>
          </p:cNvPr>
          <p:cNvGrpSpPr/>
          <p:nvPr/>
        </p:nvGrpSpPr>
        <p:grpSpPr>
          <a:xfrm>
            <a:off x="643378" y="164892"/>
            <a:ext cx="9924687" cy="5283472"/>
            <a:chOff x="28782" y="0"/>
            <a:chExt cx="9924687" cy="5283472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46C0189-08CE-087B-275C-C29A5EC1EC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782" y="0"/>
              <a:ext cx="9924687" cy="528347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2EBBD88-60AF-315B-7F8B-40273B41E6C9}"/>
                </a:ext>
              </a:extLst>
            </p:cNvPr>
            <p:cNvSpPr txBox="1"/>
            <p:nvPr/>
          </p:nvSpPr>
          <p:spPr>
            <a:xfrm flipH="1">
              <a:off x="3493284" y="493676"/>
              <a:ext cx="379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AEA32C5-645E-F595-1914-FC7BCDF1BA13}"/>
                </a:ext>
              </a:extLst>
            </p:cNvPr>
            <p:cNvSpPr txBox="1"/>
            <p:nvPr/>
          </p:nvSpPr>
          <p:spPr>
            <a:xfrm flipH="1">
              <a:off x="4417424" y="1993686"/>
              <a:ext cx="379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1259F046-99E1-7D9F-DB29-5EE109C46F12}"/>
              </a:ext>
            </a:extLst>
          </p:cNvPr>
          <p:cNvSpPr txBox="1"/>
          <p:nvPr/>
        </p:nvSpPr>
        <p:spPr>
          <a:xfrm>
            <a:off x="0" y="5599267"/>
            <a:ext cx="12191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4A: Analysis of Electroporation effects of  PAM on triple-negative breast cancer MDA-MB-231 cells using PI intake intensity measurements. Cell media was treated with CHCP at 30V (~2010 V/cm PTEF) and 25V (~1675 V/cm PTEF) for 5 minutes and this Plasma Activated media (PAM) was applied on cells, followed by analysis at multiple incubation time points (30, 60 and 120 minutes) to assess plasma-induced membrane permeability. Percentage of PI intensity indicates the degree of cell membrane electroporation, with data represented as mean ± SEM (n = 3). Statistical significance was analyzed between PAM-treated and helium-treated samples using Student’s t-test, where 30V and 25V at 2 hours incubation were *p = 0.015 and  *p = 0.010 respectively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35298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8EC4514-33B5-7CEB-F373-BDA0DB778C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DF4A2763-55A0-DBEB-C72A-8D2C0034A6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7424" y="0"/>
            <a:ext cx="10443032" cy="53065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5348DB3-AF3A-6785-80D3-4887693B14A8}"/>
              </a:ext>
            </a:extLst>
          </p:cNvPr>
          <p:cNvSpPr txBox="1"/>
          <p:nvPr/>
        </p:nvSpPr>
        <p:spPr>
          <a:xfrm>
            <a:off x="4179682" y="119669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040D95-CD59-5F5B-16E0-908517CFE56E}"/>
              </a:ext>
            </a:extLst>
          </p:cNvPr>
          <p:cNvSpPr txBox="1"/>
          <p:nvPr/>
        </p:nvSpPr>
        <p:spPr>
          <a:xfrm>
            <a:off x="5179275" y="201440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3689CA-883F-342E-358A-64719E8EC307}"/>
              </a:ext>
            </a:extLst>
          </p:cNvPr>
          <p:cNvSpPr txBox="1"/>
          <p:nvPr/>
        </p:nvSpPr>
        <p:spPr>
          <a:xfrm>
            <a:off x="124590" y="5473005"/>
            <a:ext cx="119428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4B : Analysis of Electroporation effects of  PAM on breast cancer ER+ PR+ HER2- MCF-7 cells using PI intake intensity measurements. Cell media was treated with CHCP at 30V (~2010 V/cm PTEF) and 25V (~1675 V/cm PTEF) for 5 minutes and this Plasma Activated media (PAM) was applied on cells, followed by analysis at multiple incubation time points (30, 60 and 120 minutes) to assess plasma-induced membrane permeability. Percentage of PI intensity indicates the degree of cell membrane electroporation, with data represented as mean ± SEM (n = 3). Statistical significance was analyzed between PAM-treated and helium-treated samples using 2 hours incubation were p = 0.0366 and  *p = 0.0047 respectively. 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986240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72D629-0A4A-89F9-7926-7291278034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11E116B1-53A9-D1A2-5B3D-66E1803700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8661" y="0"/>
            <a:ext cx="9954677" cy="480796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604C2FC-C5B3-0CE3-AE42-F80AB4023F7B}"/>
              </a:ext>
            </a:extLst>
          </p:cNvPr>
          <p:cNvSpPr txBox="1"/>
          <p:nvPr/>
        </p:nvSpPr>
        <p:spPr>
          <a:xfrm>
            <a:off x="4573672" y="60015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187F2D-3F7A-2D41-4970-F89A30F14B0A}"/>
              </a:ext>
            </a:extLst>
          </p:cNvPr>
          <p:cNvSpPr txBox="1"/>
          <p:nvPr/>
        </p:nvSpPr>
        <p:spPr>
          <a:xfrm>
            <a:off x="5535538" y="145709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F03C516-7ED7-4D85-E513-1BA193038CE4}"/>
              </a:ext>
            </a:extLst>
          </p:cNvPr>
          <p:cNvSpPr txBox="1"/>
          <p:nvPr/>
        </p:nvSpPr>
        <p:spPr>
          <a:xfrm>
            <a:off x="124590" y="5473005"/>
            <a:ext cx="119428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4c : Analysis of Electroporation effects of  PAM on breast cancer ER+ PR+ HER2+ BT-474  cells using PI intake intensity measurements. Cell media was treated with CHCP at 30V (~2010 V/cm PTEF) and 25V (~1675 V/cm PTEF) for 5 minutes and this Plasma Activated media (PAM) was applied on cells, followed by analysis at multiple incubation time points (30, 60 and 120 minutes) to assess plasma-induced membrane permeability. Percentage of PI intensity indicates the degree of cell membrane electroporation, with data represented as mean ± SEM (n = 3). Statistical significance was analyzed between PAM-treated and helium-treated samples using 2 hours incubation were p =0.019 and  *p = 0.042 respectively. 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590039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6</TotalTime>
  <Words>421</Words>
  <Application>Microsoft Macintosh PowerPoint</Application>
  <PresentationFormat>Widescreen</PresentationFormat>
  <Paragraphs>10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vana Murthy</dc:creator>
  <cp:lastModifiedBy>Saravana Murthy</cp:lastModifiedBy>
  <cp:revision>2</cp:revision>
  <dcterms:created xsi:type="dcterms:W3CDTF">2025-10-27T18:00:13Z</dcterms:created>
  <dcterms:modified xsi:type="dcterms:W3CDTF">2025-10-28T01:16:35Z</dcterms:modified>
</cp:coreProperties>
</file>